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8" r:id="rId2"/>
  </p:sldIdLst>
  <p:sldSz cx="6858000" cy="9144000" type="screen4x3"/>
  <p:notesSz cx="6808788" cy="99409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5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727" autoAdjust="0"/>
    <p:restoredTop sz="94660"/>
  </p:normalViewPr>
  <p:slideViewPr>
    <p:cSldViewPr snapToGrid="0" showGuides="1">
      <p:cViewPr>
        <p:scale>
          <a:sx n="110" d="100"/>
          <a:sy n="110" d="100"/>
        </p:scale>
        <p:origin x="738" y="-3090"/>
      </p:cViewPr>
      <p:guideLst>
        <p:guide orient="horz" pos="952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31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8103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1706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652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4948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2959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540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8936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1382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0215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7313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3952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0BBCD-8497-4A07-B4D5-8E93CFDD9D09}" type="datetimeFigureOut">
              <a:rPr lang="en-GB" smtClean="0"/>
              <a:t>11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30F5D-A3A3-4426-B9A4-13DDC3EF662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7144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53D4D5A-A3FD-42CB-8A3A-DCDBFBBD1303}"/>
              </a:ext>
            </a:extLst>
          </p:cNvPr>
          <p:cNvSpPr txBox="1"/>
          <p:nvPr/>
        </p:nvSpPr>
        <p:spPr>
          <a:xfrm>
            <a:off x="0" y="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1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1174391" y="1991910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9AB30A9-A54E-4621-A64C-83DC86270975}"/>
              </a:ext>
            </a:extLst>
          </p:cNvPr>
          <p:cNvSpPr txBox="1"/>
          <p:nvPr/>
        </p:nvSpPr>
        <p:spPr>
          <a:xfrm>
            <a:off x="2997806" y="1991910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F31DBBA-A535-47AB-98EB-68DF5E11EE63}"/>
              </a:ext>
            </a:extLst>
          </p:cNvPr>
          <p:cNvSpPr txBox="1"/>
          <p:nvPr/>
        </p:nvSpPr>
        <p:spPr>
          <a:xfrm>
            <a:off x="6374919" y="1991910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C3015E4-F43F-44AD-869E-426DFFF6001A}"/>
              </a:ext>
            </a:extLst>
          </p:cNvPr>
          <p:cNvSpPr txBox="1"/>
          <p:nvPr/>
        </p:nvSpPr>
        <p:spPr>
          <a:xfrm>
            <a:off x="4746133" y="1991910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4FCE4D7-725B-436F-9979-792F7F2158F6}"/>
              </a:ext>
            </a:extLst>
          </p:cNvPr>
          <p:cNvSpPr txBox="1"/>
          <p:nvPr/>
        </p:nvSpPr>
        <p:spPr>
          <a:xfrm>
            <a:off x="6394743" y="3337289"/>
            <a:ext cx="444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B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001F96E-1A1E-499B-9689-A83BA1841BB5}"/>
              </a:ext>
            </a:extLst>
          </p:cNvPr>
          <p:cNvSpPr txBox="1"/>
          <p:nvPr/>
        </p:nvSpPr>
        <p:spPr>
          <a:xfrm>
            <a:off x="3028808" y="3344168"/>
            <a:ext cx="444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B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E0341A7-36B5-4408-9CB9-70BB2E8E4AA4}"/>
              </a:ext>
            </a:extLst>
          </p:cNvPr>
          <p:cNvSpPr txBox="1"/>
          <p:nvPr/>
        </p:nvSpPr>
        <p:spPr>
          <a:xfrm>
            <a:off x="4768041" y="2709874"/>
            <a:ext cx="444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B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C83D883-AE1E-4EA3-922E-5454FE7EAC3E}"/>
              </a:ext>
            </a:extLst>
          </p:cNvPr>
          <p:cNvSpPr txBox="1"/>
          <p:nvPr/>
        </p:nvSpPr>
        <p:spPr>
          <a:xfrm>
            <a:off x="1267927" y="2709873"/>
            <a:ext cx="444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55D062E-3C9E-412D-8E62-78F134A5AD71}"/>
              </a:ext>
            </a:extLst>
          </p:cNvPr>
          <p:cNvSpPr txBox="1"/>
          <p:nvPr/>
        </p:nvSpPr>
        <p:spPr>
          <a:xfrm>
            <a:off x="2976020" y="4028356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94131F9-0FB1-46A4-996A-B342003E5DE8}"/>
              </a:ext>
            </a:extLst>
          </p:cNvPr>
          <p:cNvSpPr txBox="1"/>
          <p:nvPr/>
        </p:nvSpPr>
        <p:spPr>
          <a:xfrm>
            <a:off x="1252370" y="4018180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333A1DD-836E-4F8B-B6FC-977A9931AADA}"/>
              </a:ext>
            </a:extLst>
          </p:cNvPr>
          <p:cNvSpPr txBox="1"/>
          <p:nvPr/>
        </p:nvSpPr>
        <p:spPr>
          <a:xfrm>
            <a:off x="4739721" y="4044187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D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2DC7625-E651-41A5-BD9F-8C4F95115F28}"/>
              </a:ext>
            </a:extLst>
          </p:cNvPr>
          <p:cNvSpPr txBox="1"/>
          <p:nvPr/>
        </p:nvSpPr>
        <p:spPr>
          <a:xfrm>
            <a:off x="6346650" y="4635517"/>
            <a:ext cx="455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1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6BE2514-0152-4F11-9BB6-8D38DF404FBE}"/>
              </a:ext>
            </a:extLst>
          </p:cNvPr>
          <p:cNvSpPr txBox="1"/>
          <p:nvPr/>
        </p:nvSpPr>
        <p:spPr>
          <a:xfrm>
            <a:off x="5604955" y="5945984"/>
            <a:ext cx="1359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/>
              <a:t>untransfected</a:t>
            </a:r>
            <a:r>
              <a:rPr lang="en-GB" sz="1200" dirty="0"/>
              <a:t> cell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0A88B59-DD73-4809-A558-D95269D4D5BA}"/>
              </a:ext>
            </a:extLst>
          </p:cNvPr>
          <p:cNvSpPr txBox="1"/>
          <p:nvPr/>
        </p:nvSpPr>
        <p:spPr>
          <a:xfrm>
            <a:off x="3914278" y="5290789"/>
            <a:ext cx="1359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/>
              <a:t>untransfected</a:t>
            </a:r>
            <a:r>
              <a:rPr lang="en-GB" sz="1200" dirty="0"/>
              <a:t> cells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50E372F-56AE-4E62-BEF8-9EE76DD89A3F}"/>
              </a:ext>
            </a:extLst>
          </p:cNvPr>
          <p:cNvSpPr txBox="1"/>
          <p:nvPr/>
        </p:nvSpPr>
        <p:spPr>
          <a:xfrm>
            <a:off x="2169090" y="5285260"/>
            <a:ext cx="1359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/>
              <a:t>untransfected</a:t>
            </a:r>
            <a:r>
              <a:rPr lang="en-GB" sz="1200" dirty="0"/>
              <a:t> cell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4B1D69F-D487-4682-9D5E-F488F073DACB}"/>
              </a:ext>
            </a:extLst>
          </p:cNvPr>
          <p:cNvSpPr txBox="1"/>
          <p:nvPr/>
        </p:nvSpPr>
        <p:spPr>
          <a:xfrm>
            <a:off x="394658" y="5290790"/>
            <a:ext cx="1359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/>
              <a:t>untransfected</a:t>
            </a:r>
            <a:r>
              <a:rPr lang="en-GB" sz="1200" dirty="0"/>
              <a:t> cell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AE4B55C-F64E-4CCF-A274-5B924B1611A6}"/>
              </a:ext>
            </a:extLst>
          </p:cNvPr>
          <p:cNvSpPr txBox="1"/>
          <p:nvPr/>
        </p:nvSpPr>
        <p:spPr>
          <a:xfrm>
            <a:off x="689533" y="1129747"/>
            <a:ext cx="6626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calcium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220D22C-6BA3-4828-8FD5-FDC09726B473}"/>
              </a:ext>
            </a:extLst>
          </p:cNvPr>
          <p:cNvSpPr txBox="1"/>
          <p:nvPr/>
        </p:nvSpPr>
        <p:spPr>
          <a:xfrm>
            <a:off x="2485555" y="1126564"/>
            <a:ext cx="5036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/>
              <a:t>pERK</a:t>
            </a:r>
            <a:endParaRPr lang="en-GB" sz="12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C6FB01C-731F-4A7C-870B-9810290151B5}"/>
              </a:ext>
            </a:extLst>
          </p:cNvPr>
          <p:cNvSpPr txBox="1"/>
          <p:nvPr/>
        </p:nvSpPr>
        <p:spPr>
          <a:xfrm>
            <a:off x="4120497" y="1126563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cAMP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1F30937-DC9B-40C3-8A2F-317E5A3A77BA}"/>
              </a:ext>
            </a:extLst>
          </p:cNvPr>
          <p:cNvSpPr txBox="1"/>
          <p:nvPr/>
        </p:nvSpPr>
        <p:spPr>
          <a:xfrm>
            <a:off x="5823165" y="1137205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cAMP</a:t>
            </a: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2"/>
          <a:srcRect l="69002" t="14020" b="59053"/>
          <a:stretch/>
        </p:blipFill>
        <p:spPr>
          <a:xfrm>
            <a:off x="449537" y="609498"/>
            <a:ext cx="1193573" cy="613628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3"/>
          <a:srcRect t="14707" r="30997"/>
          <a:stretch/>
        </p:blipFill>
        <p:spPr>
          <a:xfrm>
            <a:off x="102352" y="1392983"/>
            <a:ext cx="1594169" cy="1166223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4"/>
          <a:srcRect t="15421" r="33628"/>
          <a:stretch/>
        </p:blipFill>
        <p:spPr>
          <a:xfrm>
            <a:off x="100209" y="2709873"/>
            <a:ext cx="1573213" cy="1145584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5"/>
          <a:srcRect t="16056" r="32728"/>
          <a:stretch/>
        </p:blipFill>
        <p:spPr>
          <a:xfrm>
            <a:off x="130910" y="4025923"/>
            <a:ext cx="1600313" cy="1144180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6"/>
          <a:srcRect t="17022" r="33251"/>
          <a:stretch/>
        </p:blipFill>
        <p:spPr>
          <a:xfrm>
            <a:off x="76954" y="5367279"/>
            <a:ext cx="1576427" cy="1123900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7"/>
          <a:srcRect t="15694" r="27288"/>
          <a:stretch/>
        </p:blipFill>
        <p:spPr>
          <a:xfrm>
            <a:off x="1714337" y="5340884"/>
            <a:ext cx="1717257" cy="1131046"/>
          </a:xfrm>
          <a:prstGeom prst="rect">
            <a:avLst/>
          </a:prstGeom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8"/>
          <a:srcRect l="72493" t="18634" b="56076"/>
          <a:stretch/>
        </p:blipFill>
        <p:spPr>
          <a:xfrm>
            <a:off x="2190563" y="624263"/>
            <a:ext cx="1082732" cy="565483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9"/>
          <a:srcRect t="14501" r="28504"/>
          <a:stretch/>
        </p:blipFill>
        <p:spPr>
          <a:xfrm>
            <a:off x="1752249" y="4005094"/>
            <a:ext cx="1679345" cy="1154381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10"/>
          <a:srcRect t="14088" r="26827"/>
          <a:stretch/>
        </p:blipFill>
        <p:spPr>
          <a:xfrm>
            <a:off x="1670676" y="2693619"/>
            <a:ext cx="1765781" cy="1156275"/>
          </a:xfrm>
          <a:prstGeom prst="rect">
            <a:avLst/>
          </a:prstGeom>
        </p:spPr>
      </p:pic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11"/>
          <a:srcRect t="13928" r="26872"/>
          <a:stretch/>
        </p:blipFill>
        <p:spPr>
          <a:xfrm>
            <a:off x="1701354" y="1411306"/>
            <a:ext cx="1764695" cy="1154739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12"/>
          <a:srcRect t="13574" r="30253"/>
          <a:stretch/>
        </p:blipFill>
        <p:spPr>
          <a:xfrm>
            <a:off x="3522946" y="1396957"/>
            <a:ext cx="1689085" cy="1196532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 rotWithShape="1">
          <a:blip r:embed="rId13"/>
          <a:srcRect t="12077" r="30188"/>
          <a:stretch/>
        </p:blipFill>
        <p:spPr>
          <a:xfrm>
            <a:off x="3504859" y="2712010"/>
            <a:ext cx="1684674" cy="1190877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14"/>
          <a:srcRect t="14149" r="30514"/>
          <a:stretch/>
        </p:blipFill>
        <p:spPr>
          <a:xfrm>
            <a:off x="3540997" y="4028356"/>
            <a:ext cx="1652981" cy="1155454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15"/>
          <a:srcRect t="14316" r="28374"/>
          <a:stretch/>
        </p:blipFill>
        <p:spPr>
          <a:xfrm>
            <a:off x="3519812" y="5331640"/>
            <a:ext cx="1654767" cy="1149534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16"/>
          <a:srcRect l="71154" t="12924" b="62156"/>
          <a:stretch/>
        </p:blipFill>
        <p:spPr>
          <a:xfrm>
            <a:off x="3922431" y="624263"/>
            <a:ext cx="1110710" cy="557210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17"/>
          <a:srcRect t="14426" r="37277"/>
          <a:stretch/>
        </p:blipFill>
        <p:spPr>
          <a:xfrm>
            <a:off x="5244964" y="4014710"/>
            <a:ext cx="1645340" cy="1155393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 rotWithShape="1">
          <a:blip r:embed="rId18"/>
          <a:srcRect t="14750" r="36568"/>
          <a:stretch/>
        </p:blipFill>
        <p:spPr>
          <a:xfrm>
            <a:off x="5194061" y="5348338"/>
            <a:ext cx="1663939" cy="1143711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19"/>
          <a:srcRect l="62705" t="13649" b="62070"/>
          <a:stretch/>
        </p:blipFill>
        <p:spPr>
          <a:xfrm>
            <a:off x="5333838" y="619351"/>
            <a:ext cx="1630528" cy="542922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20"/>
          <a:srcRect t="14449" r="36869"/>
          <a:stretch/>
        </p:blipFill>
        <p:spPr>
          <a:xfrm>
            <a:off x="5174579" y="2756864"/>
            <a:ext cx="1680396" cy="1155083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21"/>
          <a:srcRect t="14975" r="36802"/>
          <a:stretch/>
        </p:blipFill>
        <p:spPr>
          <a:xfrm>
            <a:off x="5208124" y="1443621"/>
            <a:ext cx="1682180" cy="1177136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142372" y="1145232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a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1950275" y="1158155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b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3800455" y="1126562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c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5396072" y="1137205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d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173777" y="2533136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e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1981680" y="2546059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f)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3831860" y="2514466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g)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5427477" y="2525109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h)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201670" y="5164946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m)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2009573" y="5177869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n)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3859753" y="5146276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o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5455370" y="5156919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p)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240654" y="3856969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/>
              <a:t>i</a:t>
            </a:r>
            <a:r>
              <a:rPr lang="en-GB" sz="1200" dirty="0"/>
              <a:t>)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2048557" y="3869892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j)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3849014" y="3855529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k)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EE3A6A0-1E95-45F8-A9A6-AA5315B7A849}"/>
              </a:ext>
            </a:extLst>
          </p:cNvPr>
          <p:cNvSpPr txBox="1"/>
          <p:nvPr/>
        </p:nvSpPr>
        <p:spPr>
          <a:xfrm>
            <a:off x="5494354" y="3848942"/>
            <a:ext cx="417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l)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23481" y="6695632"/>
            <a:ext cx="641003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pplementary Figure 1</a:t>
            </a:r>
            <a:endParaRPr lang="en-GB" sz="1200" dirty="0"/>
          </a:p>
          <a:p>
            <a:r>
              <a:rPr lang="en-GB" sz="1200" dirty="0" err="1"/>
              <a:t>Oxymetazoline</a:t>
            </a:r>
            <a:r>
              <a:rPr lang="en-GB" sz="1200" dirty="0"/>
              <a:t> responses in CHO-α1A cells (a-d), CHO-α1B cells (e-h), CHO-α1D cells (</a:t>
            </a:r>
            <a:r>
              <a:rPr lang="en-GB" sz="1200" dirty="0" err="1"/>
              <a:t>i</a:t>
            </a:r>
            <a:r>
              <a:rPr lang="en-GB" sz="1200" dirty="0"/>
              <a:t>-l) or untransfected CHO cells (m-p) for intracellular calcium </a:t>
            </a:r>
            <a:r>
              <a:rPr lang="en-GB" sz="1200" dirty="0" smtClean="0"/>
              <a:t>mobilisation </a:t>
            </a:r>
            <a:r>
              <a:rPr lang="en-GB" sz="1200" dirty="0"/>
              <a:t>(a, e, </a:t>
            </a:r>
            <a:r>
              <a:rPr lang="en-GB" sz="1200" dirty="0" err="1"/>
              <a:t>i</a:t>
            </a:r>
            <a:r>
              <a:rPr lang="en-GB" sz="1200" dirty="0"/>
              <a:t>, m), ERK1/2-phosphorylation (b, f, j, n), </a:t>
            </a:r>
            <a:r>
              <a:rPr lang="en-GB" sz="1200" baseline="30000" dirty="0"/>
              <a:t>3</a:t>
            </a:r>
            <a:r>
              <a:rPr lang="en-GB" sz="1200" dirty="0"/>
              <a:t>H-cAMP accumulation (c, g, k, o) or </a:t>
            </a:r>
            <a:r>
              <a:rPr lang="en-GB" sz="1200" baseline="30000" dirty="0"/>
              <a:t>3</a:t>
            </a:r>
            <a:r>
              <a:rPr lang="en-GB" sz="1200" dirty="0"/>
              <a:t>H-cAMP accumulation in the presence of 10μM forskolin (d, h, l, p). Data points are mean ± </a:t>
            </a:r>
            <a:r>
              <a:rPr lang="en-GB" sz="1200" dirty="0" err="1"/>
              <a:t>sem</a:t>
            </a:r>
            <a:r>
              <a:rPr lang="en-GB" sz="1200" dirty="0"/>
              <a:t> of triplicate determinations. </a:t>
            </a:r>
          </a:p>
        </p:txBody>
      </p:sp>
    </p:spTree>
    <p:extLst>
      <p:ext uri="{BB962C8B-B14F-4D97-AF65-F5344CB8AC3E}">
        <p14:creationId xmlns:p14="http://schemas.microsoft.com/office/powerpoint/2010/main" val="395568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79</TotalTime>
  <Words>149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llian Baker</dc:creator>
  <cp:lastModifiedBy>Jillian Baker</cp:lastModifiedBy>
  <cp:revision>199</cp:revision>
  <cp:lastPrinted>2021-01-13T15:30:17Z</cp:lastPrinted>
  <dcterms:created xsi:type="dcterms:W3CDTF">2020-10-15T14:42:33Z</dcterms:created>
  <dcterms:modified xsi:type="dcterms:W3CDTF">2021-02-11T22:41:02Z</dcterms:modified>
</cp:coreProperties>
</file>